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ppt/charts/chart4.xml" ContentType="application/vnd.openxmlformats-officedocument.drawingml.chart+xml"/>
  <Override PartName="/ppt/charts/chart5.xml" ContentType="application/vnd.openxmlformats-officedocument.drawingml.chart+xml"/>
  <Override PartName="/ppt/charts/chart6.xml" ContentType="application/vnd.openxmlformats-officedocument.drawingml.chart+xml"/>
  <Override PartName="/ppt/charts/chart7.xml" ContentType="application/vnd.openxmlformats-officedocument.drawingml.chart+xml"/>
  <Override PartName="/ppt/charts/chart8.xml" ContentType="application/vnd.openxmlformats-officedocument.drawingml.chart+xml"/>
  <Override PartName="/ppt/charts/chart9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cs-CZ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>
    <p:restoredLeft sz="15620"/>
    <p:restoredTop sz="94660"/>
  </p:normalViewPr>
  <p:slideViewPr>
    <p:cSldViewPr>
      <p:cViewPr varScale="1">
        <p:scale>
          <a:sx n="65" d="100"/>
          <a:sy n="65" d="100"/>
        </p:scale>
        <p:origin x="1312" y="60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raeva\Documents\Leishmania\2A\qPCR\sat-2A-mCh_cl1_diff_markers_Nadya\180919%20pfr1d,%20sherp,%20ama.xlsx" TargetMode="External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ucka\Desktop\Projects\2A\qPCR\wt-markers.xls" TargetMode="External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raeva\Documents\Leishmania\2A\qPCR\sat-2A-mCh_cl1_diff_markers_Nadya\180919%20pfr1d,%20sherp,%20ama.xlsx" TargetMode="External"/></Relationships>
</file>

<file path=ppt/charts/_rels/chart4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ucka\Desktop\Projects\2A\qPCR\wt-markers.xls" TargetMode="External"/></Relationships>
</file>

<file path=ppt/charts/_rels/chart5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kraeva\Documents\Leishmania\2A\qPCR\sat-2A-mCh_cl1_diff_markers_Nadya\180919%20pfr1d,%20sherp,%20ama.xlsx" TargetMode="External"/></Relationships>
</file>

<file path=ppt/charts/_rels/chart6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Lucka\Desktop\Projects\2A\qPCR\wt-markers.xls" TargetMode="External"/></Relationships>
</file>

<file path=ppt/charts/_rels/chart7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aeva\2A\qPCR\diffcat_markers_161019_sat2acat_from%20Lucie.xlsx" TargetMode="External"/></Relationships>
</file>

<file path=ppt/charts/_rels/chart8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aeva\2A\qPCR\diffcat_markers_161019_sat2acat_from%20Lucie.xlsx" TargetMode="External"/></Relationships>
</file>

<file path=ppt/charts/_rels/chart9.xml.rels><?xml version="1.0" encoding="UTF-8" standalone="yes"?>
<Relationships xmlns="http://schemas.openxmlformats.org/package/2006/relationships"><Relationship Id="rId1" Type="http://schemas.openxmlformats.org/officeDocument/2006/relationships/oleObject" Target="file:///F:\Kraeva\2A\qPCR\diffcat_markers_161019_sat2acat_from%20Lucie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3103402777777778"/>
          <c:y val="7.8733888888888895E-2"/>
          <c:w val="0.81723749999999995"/>
          <c:h val="0.72450449950005558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[180919 pfr1d, sherp, ama.xlsx]sherp'!$C$14:$C$16</c:f>
                <c:numCache>
                  <c:formatCode>General</c:formatCode>
                  <c:ptCount val="3"/>
                  <c:pt idx="0">
                    <c:v>2.2793821447266379E-2</c:v>
                  </c:pt>
                  <c:pt idx="1">
                    <c:v>0.35920307996525197</c:v>
                  </c:pt>
                  <c:pt idx="2">
                    <c:v>5.5248736932746983E-2</c:v>
                  </c:pt>
                </c:numCache>
              </c:numRef>
            </c:plus>
            <c:minus>
              <c:numRef>
                <c:f>'[180919 pfr1d, sherp, ama.xlsx]sherp'!$C$14:$C$16</c:f>
                <c:numCache>
                  <c:formatCode>General</c:formatCode>
                  <c:ptCount val="3"/>
                  <c:pt idx="0">
                    <c:v>2.2793821447266379E-2</c:v>
                  </c:pt>
                  <c:pt idx="1">
                    <c:v>0.35920307996525197</c:v>
                  </c:pt>
                  <c:pt idx="2">
                    <c:v>5.5248736932746983E-2</c:v>
                  </c:pt>
                </c:numCache>
              </c:numRef>
            </c:minus>
          </c:errBars>
          <c:cat>
            <c:strRef>
              <c:f>'C:\Users\kraeva\Documents\Leishmania\2A\qPCR\sat-2A-mCh_cl1_diff_markers_Nadya\[Sat2AmCherry_cl1_9.11.18.xlsx]sherp'!$A$14:$A$16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 </c:v>
                </c:pt>
              </c:strCache>
            </c:strRef>
          </c:cat>
          <c:val>
            <c:numRef>
              <c:f>'[180919 pfr1d, sherp, ama.xlsx]sherp'!$B$14:$B$16</c:f>
              <c:numCache>
                <c:formatCode>0.00</c:formatCode>
                <c:ptCount val="3"/>
                <c:pt idx="0">
                  <c:v>0.2</c:v>
                </c:pt>
                <c:pt idx="1">
                  <c:v>2.0099999999999998</c:v>
                </c:pt>
                <c:pt idx="2">
                  <c:v>0.68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3128-4EDD-81AE-DB31AD0BDE7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119579216"/>
        <c:axId val="-1119579760"/>
      </c:barChart>
      <c:catAx>
        <c:axId val="-1119579216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1119579760"/>
        <c:crosses val="autoZero"/>
        <c:auto val="1"/>
        <c:lblAlgn val="ctr"/>
        <c:lblOffset val="100"/>
        <c:noMultiLvlLbl val="0"/>
      </c:catAx>
      <c:valAx>
        <c:axId val="-1119579760"/>
        <c:scaling>
          <c:orientation val="minMax"/>
          <c:max val="2.5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-1119579216"/>
        <c:crosses val="autoZero"/>
        <c:crossBetween val="between"/>
        <c:majorUnit val="0.5"/>
        <c:minorUnit val="0.1"/>
      </c:valAx>
      <c:spPr>
        <a:noFill/>
        <a:ln w="25400">
          <a:noFill/>
        </a:ln>
      </c:spPr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323541666666666"/>
          <c:y val="6.4223333333333327E-2"/>
          <c:w val="0.84827449727808024"/>
          <c:h val="0.84167333333333338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Sherp!$B$1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Sherp!$C$2:$C$4</c:f>
                <c:numCache>
                  <c:formatCode>General</c:formatCode>
                  <c:ptCount val="3"/>
                  <c:pt idx="0">
                    <c:v>0.34110097678697204</c:v>
                  </c:pt>
                  <c:pt idx="1">
                    <c:v>0.14294748605674379</c:v>
                  </c:pt>
                  <c:pt idx="2">
                    <c:v>0.3035675373274776</c:v>
                  </c:pt>
                </c:numCache>
              </c:numRef>
            </c:plus>
            <c:minus>
              <c:numRef>
                <c:f>Sherp!$C$2:$C$4</c:f>
                <c:numCache>
                  <c:formatCode>General</c:formatCode>
                  <c:ptCount val="3"/>
                  <c:pt idx="0">
                    <c:v>0.34110097678697204</c:v>
                  </c:pt>
                  <c:pt idx="1">
                    <c:v>0.14294748605674379</c:v>
                  </c:pt>
                  <c:pt idx="2">
                    <c:v>0.3035675373274776</c:v>
                  </c:pt>
                </c:numCache>
              </c:numRef>
            </c:minus>
          </c:errBars>
          <c:cat>
            <c:strRef>
              <c:f>Sherp!$A$2:$A$4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Sherp!$B$2:$B$4</c:f>
              <c:numCache>
                <c:formatCode>General</c:formatCode>
                <c:ptCount val="3"/>
                <c:pt idx="0">
                  <c:v>0.57950526811490322</c:v>
                </c:pt>
                <c:pt idx="1">
                  <c:v>1.7677960611289463</c:v>
                </c:pt>
                <c:pt idx="2">
                  <c:v>0.656662549223484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119578672"/>
        <c:axId val="-1119578128"/>
      </c:barChart>
      <c:catAx>
        <c:axId val="-111957867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1119578128"/>
        <c:crosses val="autoZero"/>
        <c:auto val="1"/>
        <c:lblAlgn val="ctr"/>
        <c:lblOffset val="100"/>
        <c:noMultiLvlLbl val="0"/>
      </c:catAx>
      <c:valAx>
        <c:axId val="-1119578128"/>
        <c:scaling>
          <c:orientation val="minMax"/>
          <c:max val="2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-1119578672"/>
        <c:crosses val="autoZero"/>
        <c:crossBetween val="between"/>
        <c:majorUnit val="0.5"/>
        <c:min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138402777777778"/>
          <c:y val="7.8334444444444443E-2"/>
          <c:w val="0.79306597222222219"/>
          <c:h val="0.7238833333333333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[180919 pfr1d, sherp, ama.xlsx]pfr1d'!$C$13:$C$15</c:f>
                <c:numCache>
                  <c:formatCode>General</c:formatCode>
                  <c:ptCount val="3"/>
                  <c:pt idx="0">
                    <c:v>8.6626320771940143E-2</c:v>
                  </c:pt>
                  <c:pt idx="1">
                    <c:v>0.10865981469901395</c:v>
                  </c:pt>
                  <c:pt idx="2">
                    <c:v>6.2882412747075293E-3</c:v>
                  </c:pt>
                </c:numCache>
              </c:numRef>
            </c:plus>
            <c:minus>
              <c:numRef>
                <c:f>'[180919 pfr1d, sherp, ama.xlsx]pfr1d'!$C$13:$C$15</c:f>
                <c:numCache>
                  <c:formatCode>General</c:formatCode>
                  <c:ptCount val="3"/>
                  <c:pt idx="0">
                    <c:v>8.6626320771940143E-2</c:v>
                  </c:pt>
                  <c:pt idx="1">
                    <c:v>0.10865981469901395</c:v>
                  </c:pt>
                  <c:pt idx="2">
                    <c:v>6.2882412747075293E-3</c:v>
                  </c:pt>
                </c:numCache>
              </c:numRef>
            </c:minus>
          </c:errBars>
          <c:cat>
            <c:strRef>
              <c:f>'C:\Users\kraeva\Documents\Leishmania\2A\qPCR\sat-2A-mCh_cl1_diff_markers_Nadya\[Sat2AmCherry_cl1_9.11.18.xlsx]pfr1d'!$A$13:$A$15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 </c:v>
                </c:pt>
              </c:strCache>
            </c:strRef>
          </c:cat>
          <c:val>
            <c:numRef>
              <c:f>'[180919 pfr1d, sherp, ama.xlsx]pfr1d'!$B$13:$B$15</c:f>
              <c:numCache>
                <c:formatCode>0.00</c:formatCode>
                <c:ptCount val="3"/>
                <c:pt idx="0">
                  <c:v>0.73000000000000065</c:v>
                </c:pt>
                <c:pt idx="1">
                  <c:v>0.82000000000000062</c:v>
                </c:pt>
                <c:pt idx="2">
                  <c:v>0.6300000000000008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02FC-4D7F-B248-3DE3EB0B1554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119575408"/>
        <c:axId val="-1067632048"/>
      </c:barChart>
      <c:catAx>
        <c:axId val="-1119575408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1067632048"/>
        <c:crosses val="autoZero"/>
        <c:auto val="1"/>
        <c:lblAlgn val="ctr"/>
        <c:lblOffset val="100"/>
        <c:noMultiLvlLbl val="0"/>
      </c:catAx>
      <c:valAx>
        <c:axId val="-1067632048"/>
        <c:scaling>
          <c:orientation val="minMax"/>
          <c:max val="1"/>
          <c:min val="0"/>
        </c:scaling>
        <c:delete val="0"/>
        <c:axPos val="l"/>
        <c:numFmt formatCode="0.0" sourceLinked="0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-1119575408"/>
        <c:crosses val="autoZero"/>
        <c:crossBetween val="between"/>
        <c:majorUnit val="0.5"/>
        <c:minorUnit val="2.0000000000000011E-2"/>
      </c:valAx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externalData r:id="rId1">
    <c:autoUpdate val="0"/>
  </c:externalData>
</c:chartSpace>
</file>

<file path=ppt/charts/chart4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528402777777778"/>
          <c:y val="7.8334444444444443E-2"/>
          <c:w val="0.79093124999999997"/>
          <c:h val="0.84333111111111114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Pfr1d!$B$1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Pfr1d!$C$2:$C$4</c:f>
                <c:numCache>
                  <c:formatCode>General</c:formatCode>
                  <c:ptCount val="3"/>
                  <c:pt idx="0">
                    <c:v>0.54018527217416135</c:v>
                  </c:pt>
                  <c:pt idx="1">
                    <c:v>0.3285617052685828</c:v>
                  </c:pt>
                  <c:pt idx="2">
                    <c:v>0.21066917157451243</c:v>
                  </c:pt>
                </c:numCache>
              </c:numRef>
            </c:plus>
            <c:minus>
              <c:numRef>
                <c:f>Pfr1d!$C$2:$C$4</c:f>
                <c:numCache>
                  <c:formatCode>General</c:formatCode>
                  <c:ptCount val="3"/>
                  <c:pt idx="0">
                    <c:v>0.54018527217416135</c:v>
                  </c:pt>
                  <c:pt idx="1">
                    <c:v>0.3285617052685828</c:v>
                  </c:pt>
                  <c:pt idx="2">
                    <c:v>0.21066917157451243</c:v>
                  </c:pt>
                </c:numCache>
              </c:numRef>
            </c:minus>
          </c:errBars>
          <c:cat>
            <c:strRef>
              <c:f>Pfr1d!$A$2:$A$4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Pfr1d!$B$2:$B$4</c:f>
              <c:numCache>
                <c:formatCode>General</c:formatCode>
                <c:ptCount val="3"/>
                <c:pt idx="0">
                  <c:v>1.1011135210085568</c:v>
                </c:pt>
                <c:pt idx="1">
                  <c:v>2.3593186592201718</c:v>
                </c:pt>
                <c:pt idx="2">
                  <c:v>0.42480548211218994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067632592"/>
        <c:axId val="-1067638576"/>
      </c:barChart>
      <c:catAx>
        <c:axId val="-1067632592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1067638576"/>
        <c:crossesAt val="0"/>
        <c:auto val="1"/>
        <c:lblAlgn val="ctr"/>
        <c:lblOffset val="100"/>
        <c:noMultiLvlLbl val="0"/>
      </c:catAx>
      <c:valAx>
        <c:axId val="-1067638576"/>
        <c:scaling>
          <c:orientation val="minMax"/>
          <c:max val="3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-1067632592"/>
        <c:crosses val="autoZero"/>
        <c:crossBetween val="between"/>
        <c:majorUnit val="0.5"/>
        <c:min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5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337847222222222"/>
          <c:y val="9.1587573366451625E-2"/>
          <c:w val="0.77637187500000004"/>
          <c:h val="0.84312505358771372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'[180919 pfr1d, sherp, ama.xlsx]ama'!$C$13:$C$15</c:f>
                <c:numCache>
                  <c:formatCode>General</c:formatCode>
                  <c:ptCount val="3"/>
                  <c:pt idx="0">
                    <c:v>1.1305384786921221E-2</c:v>
                  </c:pt>
                  <c:pt idx="1">
                    <c:v>0.16264231611516441</c:v>
                  </c:pt>
                  <c:pt idx="2">
                    <c:v>0.13702431013864311</c:v>
                  </c:pt>
                </c:numCache>
              </c:numRef>
            </c:plus>
            <c:minus>
              <c:numRef>
                <c:f>'[180919 pfr1d, sherp, ama.xlsx]ama'!$C$13:$C$15</c:f>
                <c:numCache>
                  <c:formatCode>General</c:formatCode>
                  <c:ptCount val="3"/>
                  <c:pt idx="0">
                    <c:v>1.1305384786921221E-2</c:v>
                  </c:pt>
                  <c:pt idx="1">
                    <c:v>0.16264231611516441</c:v>
                  </c:pt>
                  <c:pt idx="2">
                    <c:v>0.13702431013864311</c:v>
                  </c:pt>
                </c:numCache>
              </c:numRef>
            </c:minus>
          </c:errBars>
          <c:cat>
            <c:strRef>
              <c:f>'C:\Users\kraeva\Documents\Leishmania\2A\qPCR\sat-2A-mCh_cl1_diff_markers_Nadya\[Sat2AmCherry_cl1_9.11.18.xlsx]ama'!$A$13:$A$15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'[180919 pfr1d, sherp, ama.xlsx]ama'!$B$13:$B$15</c:f>
              <c:numCache>
                <c:formatCode>General</c:formatCode>
                <c:ptCount val="3"/>
                <c:pt idx="0">
                  <c:v>0.18521505207974895</c:v>
                </c:pt>
                <c:pt idx="1">
                  <c:v>0.83225342035950833</c:v>
                </c:pt>
                <c:pt idx="2">
                  <c:v>1.4190094291740079</c:v>
                </c:pt>
              </c:numCache>
            </c:numRef>
          </c:val>
          <c:extLst xmlns:c16r2="http://schemas.microsoft.com/office/drawing/2015/06/chart">
            <c:ext xmlns:c16="http://schemas.microsoft.com/office/drawing/2014/chart" uri="{C3380CC4-5D6E-409C-BE32-E72D297353CC}">
              <c16:uniqueId val="{00000000-B4DD-4D4D-AD19-06E73778223A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-1067638032"/>
        <c:axId val="-1067631504"/>
      </c:barChart>
      <c:catAx>
        <c:axId val="-1067638032"/>
        <c:scaling>
          <c:orientation val="minMax"/>
        </c:scaling>
        <c:delete val="1"/>
        <c:axPos val="b"/>
        <c:numFmt formatCode="General" sourceLinked="1"/>
        <c:majorTickMark val="none"/>
        <c:minorTickMark val="none"/>
        <c:tickLblPos val="nextTo"/>
        <c:crossAx val="-1067631504"/>
        <c:crosses val="autoZero"/>
        <c:auto val="1"/>
        <c:lblAlgn val="ctr"/>
        <c:lblOffset val="100"/>
        <c:noMultiLvlLbl val="0"/>
      </c:catAx>
      <c:valAx>
        <c:axId val="-1067631504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txPr>
          <a:bodyPr rot="-60000000" vert="horz"/>
          <a:lstStyle/>
          <a:p>
            <a:pPr>
              <a:defRPr/>
            </a:pPr>
            <a:endParaRPr lang="en-US"/>
          </a:p>
        </c:txPr>
        <c:crossAx val="-1067638032"/>
        <c:crosses val="autoZero"/>
        <c:crossBetween val="between"/>
      </c:valAx>
    </c:plotArea>
    <c:plotVisOnly val="1"/>
    <c:dispBlanksAs val="gap"/>
    <c:showDLblsOverMax val="0"/>
    <c:extLst xmlns:c16r2="http://schemas.microsoft.com/office/drawing/2015/06/chart"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</c:chart>
  <c:externalData r:id="rId1">
    <c:autoUpdate val="0"/>
  </c:externalData>
</c:chartSpace>
</file>

<file path=ppt/charts/chart6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1798333333333333"/>
          <c:y val="0.12066765941122951"/>
          <c:w val="0.85302989957395015"/>
          <c:h val="0.83649287003779726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Ama!$B$1</c:f>
              <c:strCache>
                <c:ptCount val="1"/>
                <c:pt idx="0">
                  <c:v>Wt</c:v>
                </c:pt>
              </c:strCache>
            </c:strRef>
          </c:tx>
          <c:invertIfNegative val="0"/>
          <c:errBars>
            <c:errBarType val="both"/>
            <c:errValType val="cust"/>
            <c:noEndCap val="0"/>
            <c:plus>
              <c:numRef>
                <c:f>Ama!$C$2:$C$4</c:f>
                <c:numCache>
                  <c:formatCode>General</c:formatCode>
                  <c:ptCount val="3"/>
                  <c:pt idx="0">
                    <c:v>0.14292755820400088</c:v>
                  </c:pt>
                  <c:pt idx="1">
                    <c:v>0.18945740355170287</c:v>
                  </c:pt>
                  <c:pt idx="2">
                    <c:v>0.51807645656978596</c:v>
                  </c:pt>
                </c:numCache>
              </c:numRef>
            </c:plus>
            <c:minus>
              <c:numRef>
                <c:f>Ama!$C$2:$C$4</c:f>
                <c:numCache>
                  <c:formatCode>General</c:formatCode>
                  <c:ptCount val="3"/>
                  <c:pt idx="0">
                    <c:v>0.14292755820400088</c:v>
                  </c:pt>
                  <c:pt idx="1">
                    <c:v>0.18945740355170287</c:v>
                  </c:pt>
                  <c:pt idx="2">
                    <c:v>0.51807645656978596</c:v>
                  </c:pt>
                </c:numCache>
              </c:numRef>
            </c:minus>
          </c:errBars>
          <c:cat>
            <c:strRef>
              <c:f>Ama!$A$2:$A$4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Ama!$B$2:$B$4</c:f>
              <c:numCache>
                <c:formatCode>General</c:formatCode>
                <c:ptCount val="3"/>
                <c:pt idx="0">
                  <c:v>0.22367020984186689</c:v>
                </c:pt>
                <c:pt idx="1">
                  <c:v>0.65719378278051965</c:v>
                </c:pt>
                <c:pt idx="2">
                  <c:v>2.3543182168257015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067630416"/>
        <c:axId val="-1067624432"/>
      </c:barChart>
      <c:catAx>
        <c:axId val="-1067630416"/>
        <c:scaling>
          <c:orientation val="minMax"/>
        </c:scaling>
        <c:delete val="1"/>
        <c:axPos val="b"/>
        <c:numFmt formatCode="General" sourceLinked="1"/>
        <c:majorTickMark val="out"/>
        <c:minorTickMark val="none"/>
        <c:tickLblPos val="nextTo"/>
        <c:crossAx val="-1067624432"/>
        <c:crossesAt val="0"/>
        <c:auto val="1"/>
        <c:lblAlgn val="ctr"/>
        <c:lblOffset val="100"/>
        <c:noMultiLvlLbl val="0"/>
      </c:catAx>
      <c:valAx>
        <c:axId val="-1067624432"/>
        <c:scaling>
          <c:orientation val="minMax"/>
          <c:max val="3.5"/>
          <c:min val="0"/>
        </c:scaling>
        <c:delete val="0"/>
        <c:axPos val="l"/>
        <c:numFmt formatCode="General" sourceLinked="1"/>
        <c:majorTickMark val="out"/>
        <c:minorTickMark val="none"/>
        <c:tickLblPos val="nextTo"/>
        <c:crossAx val="-1067630416"/>
        <c:crosses val="autoZero"/>
        <c:crossBetween val="between"/>
        <c:majorUnit val="0.5"/>
        <c:minorUnit val="0.1"/>
      </c:valAx>
    </c:plotArea>
    <c:plotVisOnly val="1"/>
    <c:dispBlanksAs val="gap"/>
    <c:showDLblsOverMax val="0"/>
  </c:chart>
  <c:externalData r:id="rId1">
    <c:autoUpdate val="0"/>
  </c:externalData>
</c:chartSpace>
</file>

<file path=ppt/charts/chart7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038298611111111"/>
          <c:y val="4.3056666666666667E-2"/>
          <c:w val="0.83405243055555556"/>
          <c:h val="0.8397949999999999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Sherp!$C$16:$C$18</c:f>
                <c:numCache>
                  <c:formatCode>General</c:formatCode>
                  <c:ptCount val="3"/>
                  <c:pt idx="0">
                    <c:v>7.7581086747123218E-2</c:v>
                  </c:pt>
                  <c:pt idx="1">
                    <c:v>0.21607492136329021</c:v>
                  </c:pt>
                  <c:pt idx="2">
                    <c:v>1.8729797033300341E-2</c:v>
                  </c:pt>
                </c:numCache>
              </c:numRef>
            </c:plus>
            <c:minus>
              <c:numRef>
                <c:f>Sherp!$C$16:$C$18</c:f>
                <c:numCache>
                  <c:formatCode>General</c:formatCode>
                  <c:ptCount val="3"/>
                  <c:pt idx="0">
                    <c:v>7.7581086747123218E-2</c:v>
                  </c:pt>
                  <c:pt idx="1">
                    <c:v>0.21607492136329021</c:v>
                  </c:pt>
                  <c:pt idx="2">
                    <c:v>1.8729797033300341E-2</c:v>
                  </c:pt>
                </c:numCache>
              </c:numRef>
            </c:minus>
          </c:errBars>
          <c:cat>
            <c:strRef>
              <c:f>Sherp!$A$16:$A$18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Sherp!$B$16:$B$18</c:f>
              <c:numCache>
                <c:formatCode>General</c:formatCode>
                <c:ptCount val="3"/>
                <c:pt idx="0">
                  <c:v>0.36450171752936616</c:v>
                </c:pt>
                <c:pt idx="1">
                  <c:v>3.8334921064336833</c:v>
                </c:pt>
                <c:pt idx="2">
                  <c:v>0.33802463689940093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067626064"/>
        <c:axId val="-1067637488"/>
      </c:barChart>
      <c:catAx>
        <c:axId val="-1067626064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1067637488"/>
        <c:crosses val="autoZero"/>
        <c:auto val="1"/>
        <c:lblAlgn val="ctr"/>
        <c:lblOffset val="100"/>
        <c:noMultiLvlLbl val="0"/>
      </c:catAx>
      <c:valAx>
        <c:axId val="-1067637488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1067626064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8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4973453120306268"/>
          <c:y val="0.10395"/>
          <c:w val="0.81586490432644276"/>
          <c:h val="0.82737722222222221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pfr1d!$C$14:$C$16</c:f>
                <c:numCache>
                  <c:formatCode>General</c:formatCode>
                  <c:ptCount val="3"/>
                  <c:pt idx="0">
                    <c:v>0.27084480303222902</c:v>
                  </c:pt>
                  <c:pt idx="1">
                    <c:v>0.44773131426562029</c:v>
                  </c:pt>
                  <c:pt idx="2">
                    <c:v>2.4707401577997626E-2</c:v>
                  </c:pt>
                </c:numCache>
              </c:numRef>
            </c:plus>
            <c:minus>
              <c:numRef>
                <c:f>pfr1d!$C$14:$C$16</c:f>
                <c:numCache>
                  <c:formatCode>General</c:formatCode>
                  <c:ptCount val="3"/>
                  <c:pt idx="0">
                    <c:v>0.27084480303222902</c:v>
                  </c:pt>
                  <c:pt idx="1">
                    <c:v>0.44773131426562029</c:v>
                  </c:pt>
                  <c:pt idx="2">
                    <c:v>2.4707401577997626E-2</c:v>
                  </c:pt>
                </c:numCache>
              </c:numRef>
            </c:minus>
          </c:errBars>
          <c:cat>
            <c:strRef>
              <c:f>pfr1d!$A$14:$A$16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pfr1d!$B$14:$B$16</c:f>
              <c:numCache>
                <c:formatCode>General</c:formatCode>
                <c:ptCount val="3"/>
                <c:pt idx="0">
                  <c:v>1.1198915775596674</c:v>
                </c:pt>
                <c:pt idx="1">
                  <c:v>1.4926147569546218</c:v>
                </c:pt>
                <c:pt idx="2">
                  <c:v>0.58817551707881521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067633680"/>
        <c:axId val="-1067627696"/>
      </c:barChart>
      <c:catAx>
        <c:axId val="-106763368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1067627696"/>
        <c:crosses val="autoZero"/>
        <c:auto val="1"/>
        <c:lblAlgn val="ctr"/>
        <c:lblOffset val="100"/>
        <c:noMultiLvlLbl val="0"/>
      </c:catAx>
      <c:valAx>
        <c:axId val="-1067627696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106763368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charts/chart9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1"/>
    </mc:Choice>
    <mc:Fallback>
      <c:style val="1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2979149325549311"/>
          <c:y val="0.14793000000000001"/>
          <c:w val="0.82072752876249988"/>
          <c:h val="0.80901333333333336"/>
        </c:manualLayout>
      </c:layout>
      <c:barChart>
        <c:barDir val="col"/>
        <c:grouping val="clustered"/>
        <c:varyColors val="0"/>
        <c:ser>
          <c:idx val="0"/>
          <c:order val="0"/>
          <c:invertIfNegative val="0"/>
          <c:errBars>
            <c:errBarType val="both"/>
            <c:errValType val="cust"/>
            <c:noEndCap val="0"/>
            <c:plus>
              <c:numRef>
                <c:f>Ama!$C$16:$C$18</c:f>
                <c:numCache>
                  <c:formatCode>General</c:formatCode>
                  <c:ptCount val="3"/>
                  <c:pt idx="0">
                    <c:v>7.8830033283383102E-2</c:v>
                  </c:pt>
                  <c:pt idx="1">
                    <c:v>6.7972473028432637E-2</c:v>
                  </c:pt>
                  <c:pt idx="2">
                    <c:v>0.14591599370257838</c:v>
                  </c:pt>
                </c:numCache>
              </c:numRef>
            </c:plus>
            <c:minus>
              <c:numRef>
                <c:f>Ama!$C$16:$C$18</c:f>
                <c:numCache>
                  <c:formatCode>General</c:formatCode>
                  <c:ptCount val="3"/>
                  <c:pt idx="0">
                    <c:v>7.8830033283383102E-2</c:v>
                  </c:pt>
                  <c:pt idx="1">
                    <c:v>6.7972473028432637E-2</c:v>
                  </c:pt>
                  <c:pt idx="2">
                    <c:v>0.14591599370257838</c:v>
                  </c:pt>
                </c:numCache>
              </c:numRef>
            </c:minus>
          </c:errBars>
          <c:cat>
            <c:strRef>
              <c:f>Ama!$A$16:$A$18</c:f>
              <c:strCache>
                <c:ptCount val="3"/>
                <c:pt idx="0">
                  <c:v>pro</c:v>
                </c:pt>
                <c:pt idx="1">
                  <c:v>meta</c:v>
                </c:pt>
                <c:pt idx="2">
                  <c:v>ama</c:v>
                </c:pt>
              </c:strCache>
            </c:strRef>
          </c:cat>
          <c:val>
            <c:numRef>
              <c:f>Ama!$B$16:$B$18</c:f>
              <c:numCache>
                <c:formatCode>General</c:formatCode>
                <c:ptCount val="3"/>
                <c:pt idx="0">
                  <c:v>0.45604319860231696</c:v>
                </c:pt>
                <c:pt idx="1">
                  <c:v>1.0628462151075941</c:v>
                </c:pt>
                <c:pt idx="2">
                  <c:v>1.5798940246793542</c:v>
                </c:pt>
              </c:numCache>
            </c:numRef>
          </c:val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150"/>
        <c:axId val="-1067630960"/>
        <c:axId val="-1067625520"/>
      </c:barChart>
      <c:catAx>
        <c:axId val="-1067630960"/>
        <c:scaling>
          <c:orientation val="minMax"/>
        </c:scaling>
        <c:delete val="1"/>
        <c:axPos val="b"/>
        <c:numFmt formatCode="General" sourceLinked="0"/>
        <c:majorTickMark val="out"/>
        <c:minorTickMark val="none"/>
        <c:tickLblPos val="nextTo"/>
        <c:crossAx val="-1067625520"/>
        <c:crosses val="autoZero"/>
        <c:auto val="1"/>
        <c:lblAlgn val="ctr"/>
        <c:lblOffset val="100"/>
        <c:noMultiLvlLbl val="0"/>
      </c:catAx>
      <c:valAx>
        <c:axId val="-106762552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crossAx val="-1067630960"/>
        <c:crosses val="autoZero"/>
        <c:crossBetween val="between"/>
      </c:valAx>
    </c:plotArea>
    <c:plotVisOnly val="1"/>
    <c:dispBlanksAs val="gap"/>
    <c:showDLblsOverMax val="0"/>
  </c:chart>
  <c:externalData r:id="rId1">
    <c:autoUpdate val="0"/>
  </c:externalData>
</c:chartSpac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Úvodní sníme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Podnadpis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cs-CZ" smtClean="0"/>
              <a:t>Kliknutím lze upravit styl předlohy.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0268294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Nadpis a svislý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3250643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Svislý nadpis a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vislý nadpis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svislý text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4827652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Nadpis a obsah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525929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Záhlaví čás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029755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va obsah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111637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Porovnání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4" name="Zástupný symbol pro obsah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5" name="Zástupný symbol pro text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6" name="Zástupný symbol pro obsah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7" name="Zástupný symbol pro datum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8" name="Zástupný symbol pro zápatí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Zástupný symbol pro číslo snímku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31935725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Pouze nadp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datum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4" name="Zástupný symbol pro zápatí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Zástupný symbol pro číslo snímku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25711394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Prázdn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datum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3" name="Zástupný symbol pro zápatí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Zástupný symbol pro číslo snímku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98068751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Obsah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sah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02586690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Obrázek s titulke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Nadpis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obrázek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US"/>
          </a:p>
        </p:txBody>
      </p:sp>
      <p:sp>
        <p:nvSpPr>
          <p:cNvPr id="4" name="Zástupný symbol pro text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cs-CZ" smtClean="0"/>
              <a:t>Kliknutím lze upravit styly předlohy textu.</a:t>
            </a:r>
          </a:p>
        </p:txBody>
      </p:sp>
      <p:sp>
        <p:nvSpPr>
          <p:cNvPr id="5" name="Zástupný symbol pro datum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6" name="Zástupný symbol pro zápatí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Zástupný symbol pro číslo snímku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56409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Zástupný symbol pro nadpis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cs-CZ" smtClean="0"/>
              <a:t>Kliknutím lze upravit styl.</a:t>
            </a:r>
            <a:endParaRPr lang="en-US"/>
          </a:p>
        </p:txBody>
      </p:sp>
      <p:sp>
        <p:nvSpPr>
          <p:cNvPr id="3" name="Zástupný symbol pro text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cs-CZ" smtClean="0"/>
              <a:t>Kliknutím lze upravit styly předlohy textu.</a:t>
            </a:r>
          </a:p>
          <a:p>
            <a:pPr lvl="1"/>
            <a:r>
              <a:rPr lang="cs-CZ" smtClean="0"/>
              <a:t>Druhá úroveň</a:t>
            </a:r>
          </a:p>
          <a:p>
            <a:pPr lvl="2"/>
            <a:r>
              <a:rPr lang="cs-CZ" smtClean="0"/>
              <a:t>Třetí úroveň</a:t>
            </a:r>
          </a:p>
          <a:p>
            <a:pPr lvl="3"/>
            <a:r>
              <a:rPr lang="cs-CZ" smtClean="0"/>
              <a:t>Čtvrtá úroveň</a:t>
            </a:r>
          </a:p>
          <a:p>
            <a:pPr lvl="4"/>
            <a:r>
              <a:rPr lang="cs-CZ" smtClean="0"/>
              <a:t>Pátá úroveň</a:t>
            </a:r>
            <a:endParaRPr lang="en-US"/>
          </a:p>
        </p:txBody>
      </p:sp>
      <p:sp>
        <p:nvSpPr>
          <p:cNvPr id="4" name="Zástupný symbol pro datum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FD75C58-000E-48C8-808F-B8CF4557A778}" type="datetimeFigureOut">
              <a:rPr lang="en-US" smtClean="0"/>
              <a:t>8/18/2020</a:t>
            </a:fld>
            <a:endParaRPr lang="en-US"/>
          </a:p>
        </p:txBody>
      </p:sp>
      <p:sp>
        <p:nvSpPr>
          <p:cNvPr id="5" name="Zástupný symbol pro zápatí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Zástupný symbol pro číslo snímku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8C711B0-E373-4B27-9101-B3738342C71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78307023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cs-CZ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chart" Target="../charts/chart7.xml"/><Relationship Id="rId3" Type="http://schemas.openxmlformats.org/officeDocument/2006/relationships/chart" Target="../charts/chart2.xml"/><Relationship Id="rId7" Type="http://schemas.openxmlformats.org/officeDocument/2006/relationships/chart" Target="../charts/chart6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1.xml"/><Relationship Id="rId6" Type="http://schemas.openxmlformats.org/officeDocument/2006/relationships/chart" Target="../charts/chart5.xml"/><Relationship Id="rId11" Type="http://schemas.openxmlformats.org/officeDocument/2006/relationships/image" Target="../media/image1.png"/><Relationship Id="rId5" Type="http://schemas.openxmlformats.org/officeDocument/2006/relationships/chart" Target="../charts/chart4.xml"/><Relationship Id="rId10" Type="http://schemas.openxmlformats.org/officeDocument/2006/relationships/chart" Target="../charts/chart9.xml"/><Relationship Id="rId4" Type="http://schemas.openxmlformats.org/officeDocument/2006/relationships/chart" Target="../charts/chart3.xml"/><Relationship Id="rId9" Type="http://schemas.openxmlformats.org/officeDocument/2006/relationships/chart" Target="../charts/chart8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Диаграмма 1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BF639A4A-1A5B-4584-8561-5E1B79D4E70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51440030"/>
              </p:ext>
            </p:extLst>
          </p:nvPr>
        </p:nvGraphicFramePr>
        <p:xfrm>
          <a:off x="3347864" y="2636912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6" name="Graf 5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283268640"/>
              </p:ext>
            </p:extLst>
          </p:nvPr>
        </p:nvGraphicFramePr>
        <p:xfrm>
          <a:off x="3419872" y="433312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graphicFrame>
        <p:nvGraphicFramePr>
          <p:cNvPr id="10" name="Диаграмма 2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3C6324E2-11C4-40F6-95D2-CBC575A28D27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86533545"/>
              </p:ext>
            </p:extLst>
          </p:nvPr>
        </p:nvGraphicFramePr>
        <p:xfrm>
          <a:off x="301527" y="2637112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graphicFrame>
        <p:nvGraphicFramePr>
          <p:cNvPr id="17" name="Graf 16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208893212"/>
              </p:ext>
            </p:extLst>
          </p:nvPr>
        </p:nvGraphicFramePr>
        <p:xfrm>
          <a:off x="352600" y="404664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5"/>
          </a:graphicData>
        </a:graphic>
      </p:graphicFrame>
      <p:graphicFrame>
        <p:nvGraphicFramePr>
          <p:cNvPr id="18" name="Диаграмма 1">
            <a:extLst>
              <a:ext uri="{FF2B5EF4-FFF2-40B4-BE49-F238E27FC236}">
                <a16:creationId xmlns="" xmlns:xdr="http://schemas.openxmlformats.org/drawingml/2006/spreadsheetDrawing" xmlns:a16="http://schemas.microsoft.com/office/drawing/2014/main" xmlns:lc="http://schemas.openxmlformats.org/drawingml/2006/lockedCanvas" id="{160F99DB-C64E-498C-A810-F5907C0520CB}"/>
              </a:ext>
            </a:extLst>
          </p:cNvPr>
          <p:cNvGraphicFramePr>
            <a:graphicFrameLocks noChangeAspect="1"/>
          </p:cNvGraphicFramePr>
          <p:nvPr>
            <p:extLst>
              <p:ext uri="{D42A27DB-BD31-4B8C-83A1-F6EECF244321}">
                <p14:modId xmlns:p14="http://schemas.microsoft.com/office/powerpoint/2010/main" val="268128307"/>
              </p:ext>
            </p:extLst>
          </p:nvPr>
        </p:nvGraphicFramePr>
        <p:xfrm>
          <a:off x="6399808" y="2636912"/>
          <a:ext cx="2880000" cy="153953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graphicFrame>
        <p:nvGraphicFramePr>
          <p:cNvPr id="28" name="Graf 27"/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591853417"/>
              </p:ext>
            </p:extLst>
          </p:nvPr>
        </p:nvGraphicFramePr>
        <p:xfrm>
          <a:off x="6407696" y="332656"/>
          <a:ext cx="2628800" cy="1809126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7"/>
          </a:graphicData>
        </a:graphic>
      </p:graphicFrame>
      <p:sp>
        <p:nvSpPr>
          <p:cNvPr id="34" name="TextovéPole 33"/>
          <p:cNvSpPr txBox="1"/>
          <p:nvPr/>
        </p:nvSpPr>
        <p:spPr>
          <a:xfrm>
            <a:off x="1599091" y="35332"/>
            <a:ext cx="80663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 i="1" dirty="0" smtClean="0"/>
              <a:t>PFR1D</a:t>
            </a:r>
            <a:endParaRPr lang="en-US" b="1" i="1" dirty="0"/>
          </a:p>
        </p:txBody>
      </p:sp>
      <p:sp>
        <p:nvSpPr>
          <p:cNvPr id="35" name="TextovéPole 34"/>
          <p:cNvSpPr txBox="1"/>
          <p:nvPr/>
        </p:nvSpPr>
        <p:spPr>
          <a:xfrm>
            <a:off x="4572000" y="35332"/>
            <a:ext cx="803425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 i="1" dirty="0" smtClean="0"/>
              <a:t>SHERP</a:t>
            </a:r>
            <a:endParaRPr lang="en-US" b="1" i="1" dirty="0"/>
          </a:p>
        </p:txBody>
      </p:sp>
      <p:sp>
        <p:nvSpPr>
          <p:cNvPr id="36" name="TextovéPole 35"/>
          <p:cNvSpPr txBox="1"/>
          <p:nvPr/>
        </p:nvSpPr>
        <p:spPr>
          <a:xfrm>
            <a:off x="7523856" y="36000"/>
            <a:ext cx="665567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cs-CZ" b="1" i="1" dirty="0" smtClean="0"/>
              <a:t>AMA</a:t>
            </a:r>
            <a:endParaRPr lang="en-US" b="1" i="1" dirty="0"/>
          </a:p>
        </p:txBody>
      </p:sp>
      <p:sp>
        <p:nvSpPr>
          <p:cNvPr id="37" name="TextBox 6"/>
          <p:cNvSpPr txBox="1"/>
          <p:nvPr/>
        </p:nvSpPr>
        <p:spPr>
          <a:xfrm>
            <a:off x="84312" y="2348880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B</a:t>
            </a:r>
            <a:endParaRPr lang="ru-RU" b="1" dirty="0"/>
          </a:p>
        </p:txBody>
      </p:sp>
      <p:sp>
        <p:nvSpPr>
          <p:cNvPr id="38" name="TextBox 7"/>
          <p:cNvSpPr txBox="1"/>
          <p:nvPr/>
        </p:nvSpPr>
        <p:spPr>
          <a:xfrm>
            <a:off x="84312" y="248646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b="1" dirty="0" smtClean="0"/>
              <a:t>A</a:t>
            </a:r>
            <a:endParaRPr lang="ru-RU" b="1" dirty="0"/>
          </a:p>
        </p:txBody>
      </p:sp>
      <p:sp>
        <p:nvSpPr>
          <p:cNvPr id="39" name="TextBox 6"/>
          <p:cNvSpPr txBox="1"/>
          <p:nvPr/>
        </p:nvSpPr>
        <p:spPr>
          <a:xfrm>
            <a:off x="84312" y="4437112"/>
            <a:ext cx="43204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cs-CZ" b="1" dirty="0"/>
              <a:t>C</a:t>
            </a:r>
            <a:endParaRPr lang="ru-RU" b="1" dirty="0"/>
          </a:p>
        </p:txBody>
      </p:sp>
      <p:graphicFrame>
        <p:nvGraphicFramePr>
          <p:cNvPr id="20" name="Graf 1"/>
          <p:cNvGraphicFramePr/>
          <p:nvPr>
            <p:extLst>
              <p:ext uri="{D42A27DB-BD31-4B8C-83A1-F6EECF244321}">
                <p14:modId xmlns:p14="http://schemas.microsoft.com/office/powerpoint/2010/main" val="695503680"/>
              </p:ext>
            </p:extLst>
          </p:nvPr>
        </p:nvGraphicFramePr>
        <p:xfrm>
          <a:off x="3347864" y="4725144"/>
          <a:ext cx="288000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8"/>
          </a:graphicData>
        </a:graphic>
      </p:graphicFrame>
      <p:graphicFrame>
        <p:nvGraphicFramePr>
          <p:cNvPr id="21" name="Graf 1"/>
          <p:cNvGraphicFramePr/>
          <p:nvPr>
            <p:extLst>
              <p:ext uri="{D42A27DB-BD31-4B8C-83A1-F6EECF244321}">
                <p14:modId xmlns:p14="http://schemas.microsoft.com/office/powerpoint/2010/main" val="3504358107"/>
              </p:ext>
            </p:extLst>
          </p:nvPr>
        </p:nvGraphicFramePr>
        <p:xfrm>
          <a:off x="300336" y="4621778"/>
          <a:ext cx="2862860" cy="1800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9"/>
          </a:graphicData>
        </a:graphic>
      </p:graphicFrame>
      <p:graphicFrame>
        <p:nvGraphicFramePr>
          <p:cNvPr id="22" name="Graf 1"/>
          <p:cNvGraphicFramePr/>
          <p:nvPr>
            <p:extLst>
              <p:ext uri="{D42A27DB-BD31-4B8C-83A1-F6EECF244321}">
                <p14:modId xmlns:p14="http://schemas.microsoft.com/office/powerpoint/2010/main" val="1633611857"/>
              </p:ext>
            </p:extLst>
          </p:nvPr>
        </p:nvGraphicFramePr>
        <p:xfrm>
          <a:off x="6372200" y="4542068"/>
          <a:ext cx="2806432" cy="183926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10"/>
          </a:graphicData>
        </a:graphic>
      </p:graphicFrame>
      <p:pic>
        <p:nvPicPr>
          <p:cNvPr id="1027" name="Picture 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28316" y="6304192"/>
            <a:ext cx="2232248" cy="2959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0" name="Picture 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764185" y="6313695"/>
            <a:ext cx="2304256" cy="3055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41" name="Picture 3"/>
          <p:cNvPicPr>
            <a:picLocks noChangeAspect="1" noChangeArrowheads="1"/>
          </p:cNvPicPr>
          <p:nvPr/>
        </p:nvPicPr>
        <p:blipFill>
          <a:blip r:embed="rId11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723684" y="6313695"/>
            <a:ext cx="2232248" cy="295989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chemeClr val="accent1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chemeClr val="tx1"/>
                </a:solidFill>
                <a:miter lim="800000"/>
                <a:headEnd/>
                <a:tailEnd/>
              </a14:hiddenLine>
            </a:ext>
          </a:extLst>
        </p:spPr>
      </p:pic>
    </p:spTree>
    <p:extLst>
      <p:ext uri="{BB962C8B-B14F-4D97-AF65-F5344CB8AC3E}">
        <p14:creationId xmlns:p14="http://schemas.microsoft.com/office/powerpoint/2010/main" val="3501177636"/>
      </p:ext>
    </p:extLst>
  </p:cSld>
  <p:clrMapOvr>
    <a:masterClrMapping/>
  </p:clrMapOvr>
</p:sld>
</file>

<file path=ppt/theme/theme1.xml><?xml version="1.0" encoding="utf-8"?>
<a:theme xmlns:a="http://schemas.openxmlformats.org/drawingml/2006/main" name="Motiv systému Office">
  <a:themeElements>
    <a:clrScheme name="Kancelář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Kancelář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Kancelář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66</TotalTime>
  <Words>6</Words>
  <Application>Microsoft Office PowerPoint</Application>
  <PresentationFormat>On-screen Show (4:3)</PresentationFormat>
  <Paragraphs>6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4" baseType="lpstr">
      <vt:lpstr>Arial</vt:lpstr>
      <vt:lpstr>Calibri</vt:lpstr>
      <vt:lpstr>Motiv systému Offic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zentace aplikace PowerPoint</dc:title>
  <dc:creator>Lucka</dc:creator>
  <cp:lastModifiedBy>yurchenko</cp:lastModifiedBy>
  <cp:revision>14</cp:revision>
  <dcterms:created xsi:type="dcterms:W3CDTF">2020-08-13T13:10:25Z</dcterms:created>
  <dcterms:modified xsi:type="dcterms:W3CDTF">2020-08-18T16:05:51Z</dcterms:modified>
</cp:coreProperties>
</file>